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90" d="100"/>
          <a:sy n="90" d="100"/>
        </p:scale>
        <p:origin x="-3036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F3A1E-8653-45F6-9281-A4396B20CD18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52991-8801-4BF9-878A-EE85F965DA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57059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F3A1E-8653-45F6-9281-A4396B20CD18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52991-8801-4BF9-878A-EE85F965DA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540706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F3A1E-8653-45F6-9281-A4396B20CD18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52991-8801-4BF9-878A-EE85F965DA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648362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F3A1E-8653-45F6-9281-A4396B20CD18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52991-8801-4BF9-878A-EE85F965DA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27010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F3A1E-8653-45F6-9281-A4396B20CD18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52991-8801-4BF9-878A-EE85F965DA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48995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F3A1E-8653-45F6-9281-A4396B20CD18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52991-8801-4BF9-878A-EE85F965DA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6925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F3A1E-8653-45F6-9281-A4396B20CD18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52991-8801-4BF9-878A-EE85F965DA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217679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F3A1E-8653-45F6-9281-A4396B20CD18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52991-8801-4BF9-878A-EE85F965DA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03806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F3A1E-8653-45F6-9281-A4396B20CD18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52991-8801-4BF9-878A-EE85F965DA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32849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F3A1E-8653-45F6-9281-A4396B20CD18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52991-8801-4BF9-878A-EE85F965DA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3667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F3A1E-8653-45F6-9281-A4396B20CD18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52991-8801-4BF9-878A-EE85F965DA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914315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2F3A1E-8653-45F6-9281-A4396B20CD18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452991-8801-4BF9-878A-EE85F965DA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58320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7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0450"/>
          <a:stretch/>
        </p:blipFill>
        <p:spPr bwMode="auto">
          <a:xfrm>
            <a:off x="193992" y="677190"/>
            <a:ext cx="3710940" cy="281940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4" name="Grafik 8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545" y="3496590"/>
            <a:ext cx="5756910" cy="3524885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24677" y="3649436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/>
                <a:cs typeface="Arial"/>
              </a:rPr>
              <a:t>B</a:t>
            </a:r>
            <a:endParaRPr lang="de-DE" dirty="0">
              <a:latin typeface="Arial"/>
              <a:cs typeface="Arial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24677" y="969926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/>
                <a:cs typeface="Arial"/>
              </a:rPr>
              <a:t>A</a:t>
            </a:r>
            <a:endParaRPr lang="de-DE" dirty="0">
              <a:latin typeface="Arial"/>
              <a:cs typeface="Arial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87590" y="7161767"/>
            <a:ext cx="6653778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. </a:t>
            </a:r>
            <a:endParaRPr lang="en-US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Linear correlation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100" baseline="-25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x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(ng/mL) – Dose (mg/m</a:t>
            </a:r>
            <a:r>
              <a:rPr lang="en-US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/d). </a:t>
            </a:r>
          </a:p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Concentration of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orinostat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in plasma according to dose level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22809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</Words>
  <Application>Microsoft Office PowerPoint</Application>
  <PresentationFormat>Bildschirmpräsentation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versitätsklinikum Heidelbe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vantilbu</dc:creator>
  <cp:lastModifiedBy>vantilbu</cp:lastModifiedBy>
  <cp:revision>4</cp:revision>
  <dcterms:created xsi:type="dcterms:W3CDTF">2019-06-14T10:43:05Z</dcterms:created>
  <dcterms:modified xsi:type="dcterms:W3CDTF">2019-08-02T16:14:53Z</dcterms:modified>
</cp:coreProperties>
</file>